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5" d="100"/>
          <a:sy n="115" d="100"/>
        </p:scale>
        <p:origin x="24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269F3-A73F-4DEB-BB3B-88FBCCFC6010}" type="datetimeFigureOut">
              <a:rPr lang="zh-CN" altLang="en-US" smtClean="0"/>
              <a:t>2019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7D804-758D-4BAF-BB78-13EC9FFE3C9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50602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269F3-A73F-4DEB-BB3B-88FBCCFC6010}" type="datetimeFigureOut">
              <a:rPr lang="zh-CN" altLang="en-US" smtClean="0"/>
              <a:t>2019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7D804-758D-4BAF-BB78-13EC9FFE3C9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49287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269F3-A73F-4DEB-BB3B-88FBCCFC6010}" type="datetimeFigureOut">
              <a:rPr lang="zh-CN" altLang="en-US" smtClean="0"/>
              <a:t>2019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7D804-758D-4BAF-BB78-13EC9FFE3C9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0697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269F3-A73F-4DEB-BB3B-88FBCCFC6010}" type="datetimeFigureOut">
              <a:rPr lang="zh-CN" altLang="en-US" smtClean="0"/>
              <a:t>2019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7D804-758D-4BAF-BB78-13EC9FFE3C9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7107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269F3-A73F-4DEB-BB3B-88FBCCFC6010}" type="datetimeFigureOut">
              <a:rPr lang="zh-CN" altLang="en-US" smtClean="0"/>
              <a:t>2019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7D804-758D-4BAF-BB78-13EC9FFE3C9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98400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269F3-A73F-4DEB-BB3B-88FBCCFC6010}" type="datetimeFigureOut">
              <a:rPr lang="zh-CN" altLang="en-US" smtClean="0"/>
              <a:t>2019/6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7D804-758D-4BAF-BB78-13EC9FFE3C9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77798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269F3-A73F-4DEB-BB3B-88FBCCFC6010}" type="datetimeFigureOut">
              <a:rPr lang="zh-CN" altLang="en-US" smtClean="0"/>
              <a:t>2019/6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7D804-758D-4BAF-BB78-13EC9FFE3C9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5064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269F3-A73F-4DEB-BB3B-88FBCCFC6010}" type="datetimeFigureOut">
              <a:rPr lang="zh-CN" altLang="en-US" smtClean="0"/>
              <a:t>2019/6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7D804-758D-4BAF-BB78-13EC9FFE3C9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5739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269F3-A73F-4DEB-BB3B-88FBCCFC6010}" type="datetimeFigureOut">
              <a:rPr lang="zh-CN" altLang="en-US" smtClean="0"/>
              <a:t>2019/6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7D804-758D-4BAF-BB78-13EC9FFE3C9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77309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269F3-A73F-4DEB-BB3B-88FBCCFC6010}" type="datetimeFigureOut">
              <a:rPr lang="zh-CN" altLang="en-US" smtClean="0"/>
              <a:t>2019/6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7D804-758D-4BAF-BB78-13EC9FFE3C9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0619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269F3-A73F-4DEB-BB3B-88FBCCFC6010}" type="datetimeFigureOut">
              <a:rPr lang="zh-CN" altLang="en-US" smtClean="0"/>
              <a:t>2019/6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7D804-758D-4BAF-BB78-13EC9FFE3C9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9531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3269F3-A73F-4DEB-BB3B-88FBCCFC6010}" type="datetimeFigureOut">
              <a:rPr lang="zh-CN" altLang="en-US" smtClean="0"/>
              <a:t>2019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77D804-758D-4BAF-BB78-13EC9FFE3C9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58085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3389" y="1606550"/>
            <a:ext cx="11441147" cy="2825750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2324100" y="4694535"/>
            <a:ext cx="8559800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zh-CN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IR10 predicted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litron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RepeatMasker and EAHelitron in IGV</a:t>
            </a:r>
            <a:endParaRPr lang="zh-CN" altLang="zh-CN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70369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0536" y="0"/>
            <a:ext cx="6646164" cy="4555763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1638300" y="4370591"/>
            <a:ext cx="9004300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zh-CN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of genome size,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litron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umber and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litron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nsity of 51 genomes (exclude maize and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altLang="zh-CN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pus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(a) Histogram of genome size. (b) r of genome size with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litron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umber (c) r of genome size with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litron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nsity. (d) Dot plot of genome size with Helitron number (e) Histogram of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litron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umbers. (f) r of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litron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umber with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litron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nsity. (g) Dot plot of genome size with Helitron density. (h) Dot plot of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litron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with Helitron density. (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Histogram of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litron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nsity.</a:t>
            </a:r>
            <a:endParaRPr lang="zh-CN" altLang="zh-CN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65060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1353312" y="5367635"/>
            <a:ext cx="8902700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zh-CN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t plot of LDA samples. The two test sample dots near the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thaliana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.</a:t>
            </a:r>
            <a:endParaRPr lang="zh-CN" altLang="zh-CN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5264" y="479284"/>
            <a:ext cx="7206278" cy="48883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89243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0396" y="462534"/>
            <a:ext cx="9905342" cy="4782566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2235200" y="5520035"/>
            <a:ext cx="8496300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zh-CN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t plot of genome size and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litron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nsities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16 Brassicaceae genomes.</a:t>
            </a:r>
            <a:endParaRPr lang="zh-CN" altLang="zh-CN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23771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0648" y="148889"/>
            <a:ext cx="10918810" cy="4756912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266700" y="4688175"/>
            <a:ext cx="11925300" cy="21698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zh-CN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assicaceae phylogenetic trees. Dendrogram of 15 Brassicaceae genome hierarchical cluster result and two known phylogeny. (a) Dendrogram made by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litron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nsity and genome size. (b) Phylogenic tree from ancestral Brassicaceae karyotype (ABK) 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melineae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CK), 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lepineae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CK) ancestral karyotypes genome reconstruction, numbers are species divergence time million years ago (Mya). (c) Phylogenic tree was constructed with sequences corresponding to the nuclear ribosomal ITS-1, 5.8S ribosomal RNA, and ITS-2 region identified.</a:t>
            </a:r>
            <a:endParaRPr lang="zh-CN" altLang="zh-CN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51630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1118" y="147851"/>
            <a:ext cx="7662164" cy="5985708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152400" y="5934670"/>
            <a:ext cx="120396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zh-CN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litron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serted examples in IGV. First row is </a:t>
            </a:r>
            <a:r>
              <a:rPr lang="en-US" altLang="zh-CN" kern="1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ome sequence,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is coding-gene, third row is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litron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rrow is gene and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litron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rection (a) exon; (b)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litron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kern="1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ght </a:t>
            </a:r>
            <a:r>
              <a:rPr lang="en-US" altLang="zh-CN" kern="1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ports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terminator of translation; (c) intron; (d) intergenic region.</a:t>
            </a:r>
            <a:endParaRPr lang="zh-CN" altLang="zh-CN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286583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0"/>
            <a:ext cx="12197215" cy="6096000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50798" y="6007100"/>
            <a:ext cx="1219721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zh-CN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7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45 day live plant photos of 18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thaliana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cotypes: (a) Col-0; (b) Can-0; (c) Zu-0; (d) Po-0; (e) Hi-0; (f) Oy-0; (g) Wu-0; (h) Sf-2; (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t-1; (j) Mt-0; (k) Edi-0; (l) Tsu-0; (m) Bur-0; (n) Rsch-4; (o) Ler-0; (p) Ws-0; (q) Wil-2; (r) Kn-0.</a:t>
            </a:r>
            <a:endParaRPr lang="zh-CN" altLang="zh-CN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1620628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250" y="0"/>
            <a:ext cx="11588750" cy="5804964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76200" y="5804964"/>
            <a:ext cx="1203007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</a:rPr>
              <a:t>Fig. </a:t>
            </a:r>
            <a:r>
              <a:rPr lang="en-US" altLang="zh-CN" b="1" dirty="0" smtClean="0">
                <a:latin typeface="Times New Roman" panose="02020603050405020304" pitchFamily="18" charset="0"/>
              </a:rPr>
              <a:t>S8</a:t>
            </a:r>
            <a:r>
              <a:rPr lang="en-US" altLang="zh-CN" dirty="0" smtClean="0">
                <a:latin typeface="Times New Roman" panose="02020603050405020304" pitchFamily="18" charset="0"/>
              </a:rPr>
              <a:t> </a:t>
            </a:r>
            <a:r>
              <a:rPr lang="en-US" altLang="zh-CN" i="1" dirty="0">
                <a:latin typeface="Times New Roman" panose="02020603050405020304" pitchFamily="18" charset="0"/>
              </a:rPr>
              <a:t>Helitron</a:t>
            </a:r>
            <a:r>
              <a:rPr lang="en-US" altLang="zh-CN" dirty="0">
                <a:latin typeface="Times New Roman" panose="02020603050405020304" pitchFamily="18" charset="0"/>
              </a:rPr>
              <a:t> distribution of 18 </a:t>
            </a:r>
            <a:r>
              <a:rPr lang="en-US" altLang="zh-CN" i="1" dirty="0">
                <a:latin typeface="Times New Roman" panose="02020603050405020304" pitchFamily="18" charset="0"/>
              </a:rPr>
              <a:t>A. thaliana</a:t>
            </a:r>
            <a:r>
              <a:rPr lang="en-US" altLang="zh-CN" dirty="0">
                <a:latin typeface="Times New Roman" panose="02020603050405020304" pitchFamily="18" charset="0"/>
              </a:rPr>
              <a:t> ecotype genomes. The black blocks of chromosome are centromeres, green blocks height present </a:t>
            </a:r>
            <a:r>
              <a:rPr lang="en-US" altLang="zh-CN" i="1" dirty="0">
                <a:latin typeface="Times New Roman" panose="02020603050405020304" pitchFamily="18" charset="0"/>
              </a:rPr>
              <a:t>Helitron</a:t>
            </a:r>
            <a:r>
              <a:rPr lang="en-US" altLang="zh-CN" dirty="0">
                <a:latin typeface="Times New Roman" panose="02020603050405020304" pitchFamily="18" charset="0"/>
              </a:rPr>
              <a:t> counts. These 18 ecotypes have similar </a:t>
            </a:r>
            <a:r>
              <a:rPr lang="en-US" altLang="zh-CN" i="1" dirty="0">
                <a:latin typeface="Times New Roman" panose="02020603050405020304" pitchFamily="18" charset="0"/>
              </a:rPr>
              <a:t>Helitron</a:t>
            </a:r>
            <a:r>
              <a:rPr lang="en-US" altLang="zh-CN" dirty="0">
                <a:latin typeface="Times New Roman" panose="02020603050405020304" pitchFamily="18" charset="0"/>
              </a:rPr>
              <a:t> distribution, which </a:t>
            </a:r>
            <a:r>
              <a:rPr lang="en-US" altLang="zh-CN" i="1" dirty="0">
                <a:latin typeface="Times New Roman" panose="02020603050405020304" pitchFamily="18" charset="0"/>
              </a:rPr>
              <a:t>Helitrons</a:t>
            </a:r>
            <a:r>
              <a:rPr lang="en-US" altLang="zh-CN" dirty="0">
                <a:latin typeface="Times New Roman" panose="02020603050405020304" pitchFamily="18" charset="0"/>
              </a:rPr>
              <a:t> preferred to locate around centromeres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0249392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464</Words>
  <Application>Microsoft Office PowerPoint</Application>
  <PresentationFormat>宽屏</PresentationFormat>
  <Paragraphs>8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4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U Ken</dc:creator>
  <cp:lastModifiedBy>HU Ken</cp:lastModifiedBy>
  <cp:revision>18</cp:revision>
  <dcterms:created xsi:type="dcterms:W3CDTF">2019-01-21T11:24:56Z</dcterms:created>
  <dcterms:modified xsi:type="dcterms:W3CDTF">2019-06-06T09:47:00Z</dcterms:modified>
</cp:coreProperties>
</file>